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6" r:id="rId2"/>
    <p:sldId id="265" r:id="rId3"/>
    <p:sldId id="267" r:id="rId4"/>
    <p:sldId id="268" r:id="rId5"/>
    <p:sldId id="256" r:id="rId6"/>
    <p:sldId id="263" r:id="rId7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4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A306A-655D-4BDF-BBE0-F78B0AE43FAD}" type="datetimeFigureOut">
              <a:rPr lang="zh-CN" altLang="en-US" smtClean="0"/>
              <a:t>2025/3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595E8-6CDA-4EFA-9100-CC3674C155B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96C778FC-3ABD-D39C-736E-2FF622C6B1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9192" y="173454"/>
            <a:ext cx="10333616" cy="65110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3888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FE0EFA-A66B-A7E9-3332-2220CEC9035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496916B-FB38-2550-F46F-1483E9C43583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1567180" y="1350010"/>
            <a:ext cx="8874760" cy="22025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S1 Structure diagram of </a:t>
            </a:r>
            <a:r>
              <a:rPr lang="en-US" altLang="zh-CN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zh-CN" altLang="en-US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wo</a:t>
            </a:r>
            <a:r>
              <a:rPr lang="zh-CN" altLang="en-US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ptamers</a:t>
            </a:r>
            <a:r>
              <a:rPr lang="zh-CN" altLang="en-US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b="1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pc001OA and Apc001OA-d6</a:t>
            </a:r>
            <a:endParaRPr lang="en-US" altLang="zh-CN" sz="1600" b="1" kern="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ructure diagram of the apta</a:t>
            </a:r>
            <a:r>
              <a:rPr lang="en-US" altLang="zh-CN" sz="16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r Apc001OA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ructure diagram of the apta</a:t>
            </a:r>
            <a:r>
              <a:rPr lang="en-US" altLang="zh-CN" sz="16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r Apc001OA-d6</a:t>
            </a:r>
            <a:endParaRPr lang="en-US" altLang="zh-CN" sz="1600" kern="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structure diagram was obtained from Law Sau Fai Institute for Advancing Translational Medicine in Bone and Joint Diseases (TMBJ), School of Chinese Medicine, Hong Kong Baptist University</a:t>
            </a:r>
            <a:endParaRPr lang="zh-CN" altLang="en-US" sz="1600" kern="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8018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F3274AB-7467-AACE-37E7-FD1E855851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51403"/>
            <a:ext cx="12192000" cy="3755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9662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1C263A0-C3A3-9F8F-38D1-DAF3FC1F62E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24894DC8-D900-F881-29B2-303D79F67B9B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1567180" y="1350010"/>
            <a:ext cx="8874760" cy="26334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S2 Other characteristics of trabecular bone microarchitecture properties of mice after 12 weeks of treatment </a:t>
            </a:r>
          </a:p>
          <a:p>
            <a:pPr algn="just">
              <a:lnSpc>
                <a:spcPct val="150000"/>
              </a:lnSpc>
            </a:pP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b. BS/TV: Trabecular bone surface area per total volume, </a:t>
            </a:r>
            <a:r>
              <a:rPr lang="en-US" altLang="zh-CN" sz="1600" kern="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b.Conn.D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Trabecular connectivity density, Tb.BS/BV: Trabecular bone surface area per bone volume, </a:t>
            </a:r>
            <a:r>
              <a:rPr lang="en-US" altLang="zh-CN" sz="1600" kern="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b.SMI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Trabecular structure model index, SHAM: sham, PBS: phosphate buffered saline, Apc001OA and APC001OA-d6 represent the two groups treated with the two sclerostin aptamers, ALN: alendronate, PTH 1-34: teriparatide.</a:t>
            </a:r>
          </a:p>
          <a:p>
            <a:pPr algn="just">
              <a:lnSpc>
                <a:spcPct val="150000"/>
              </a:lnSpc>
            </a:pPr>
            <a:endParaRPr lang="en-US" altLang="zh-CN" sz="1600" kern="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53400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CDF0A64-E600-5248-1623-4212E8C6AB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28026"/>
            <a:ext cx="12192000" cy="5828458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1567180" y="1350010"/>
            <a:ext cx="8874760" cy="39876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.S3 Typical images of the liver, spleen, lungs and kidneys of mice at euthanasia </a:t>
            </a: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&amp;E staining of the liver of mice at euthanasia, Scale bar=50um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 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&amp;E staining of the spleen of mice at euthanasia, Scale bar=50um 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. 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&amp;E staining of the lungs of mice at euthanasia, Scale bar=50um 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altLang="zh-CN" sz="1600" b="1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. 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&amp;E staining of the kidneys of mice at euthanasia, Scale bar=50um 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en-US" altLang="zh-CN" sz="1600" kern="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&amp;E: hematoxylin and eosin, SHAM: sham, PBS: phosphate buffered saline, Apc001OA and APC001OA-d6 represent the two groups treated with the </a:t>
            </a:r>
            <a:r>
              <a:rPr lang="en-US" altLang="zh-CN" sz="1600" kern="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wo sclerostin aptamers</a:t>
            </a:r>
            <a:r>
              <a:rPr lang="en-US" altLang="zh-CN" sz="16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LN: alendronate, PTH 1-34: teriparatide </a:t>
            </a:r>
            <a:endParaRPr lang="zh-CN" altLang="en-US" sz="1600" kern="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DdiOTA3N2ZjNDJjZDUwMmFiZjUwOTU3YmI3Zjc3Mzg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3</TotalTime>
  <Words>288</Words>
  <Application>Microsoft Office PowerPoint</Application>
  <PresentationFormat>宽屏</PresentationFormat>
  <Paragraphs>13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冰娜 周</dc:creator>
  <cp:lastModifiedBy>冰娜 周</cp:lastModifiedBy>
  <cp:revision>21</cp:revision>
  <dcterms:created xsi:type="dcterms:W3CDTF">2024-08-29T02:23:00Z</dcterms:created>
  <dcterms:modified xsi:type="dcterms:W3CDTF">2025-03-07T06:22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87D24A4E6654AD384F2CB831D23DB41_12</vt:lpwstr>
  </property>
  <property fmtid="{D5CDD505-2E9C-101B-9397-08002B2CF9AE}" pid="3" name="KSOProductBuildVer">
    <vt:lpwstr>2052-12.1.0.16120</vt:lpwstr>
  </property>
</Properties>
</file>